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81" d="100"/>
          <a:sy n="81" d="100"/>
        </p:scale>
        <p:origin x="-280" y="-240"/>
      </p:cViewPr>
      <p:guideLst>
        <p:guide orient="horz" pos="3170"/>
        <p:guide pos="58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906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8602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7974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47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3843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2061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70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5752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9070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9394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6303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079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4" Type="http://schemas.openxmlformats.org/officeDocument/2006/relationships/image" Target="../media/image6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4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4" Type="http://schemas.openxmlformats.org/officeDocument/2006/relationships/image" Target="../media/image12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Bild 9" descr="MMH3438 ileum 2-1 Casp3 x400 scale bar 20um 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6592" y="2179507"/>
            <a:ext cx="3980949" cy="299146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9" name="Bild 8" descr="MMH3443 ileum 1-10 Casp3 x400 scale bar 20um 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7770" y="2191460"/>
            <a:ext cx="3976335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Bild 4" descr="MMH3463 ileum 1-1 Casp3 x400 scale bar 20um 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5" y="2195192"/>
            <a:ext cx="3976331" cy="298799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81250" y="328670"/>
            <a:ext cx="58221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 smtClean="0">
                <a:latin typeface="Arial"/>
                <a:cs typeface="Arial"/>
              </a:rPr>
              <a:t>A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825200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Apoptotic</a:t>
            </a:r>
            <a:r>
              <a:rPr lang="de-DE" sz="4000" b="1" dirty="0" smtClean="0">
                <a:latin typeface="Arial"/>
                <a:cs typeface="Arial"/>
              </a:rPr>
              <a:t> Cells </a:t>
            </a:r>
            <a:r>
              <a:rPr lang="de-DE" sz="4000" b="1" dirty="0" smtClean="0">
                <a:latin typeface="Arial"/>
                <a:cs typeface="Arial"/>
              </a:rPr>
              <a:t>(ILEUM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400 </a:t>
            </a:r>
            <a:r>
              <a:rPr lang="de-DE" sz="2400" b="1" dirty="0" smtClean="0">
                <a:latin typeface="Arial"/>
                <a:cs typeface="Arial"/>
              </a:rPr>
              <a:t>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</a:t>
            </a:r>
            <a:r>
              <a:rPr lang="de-DE" sz="2400" b="1" dirty="0">
                <a:latin typeface="Arial"/>
                <a:cs typeface="Arial"/>
              </a:rPr>
              <a:t>2</a:t>
            </a:r>
            <a:r>
              <a:rPr lang="de-DE" sz="2400" b="1" dirty="0" smtClean="0">
                <a:latin typeface="Arial"/>
                <a:cs typeface="Arial"/>
              </a:rPr>
              <a:t>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776461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Bild 7" descr="MMH3438 ileum 2-1 Ki67 x100 scale bar 100um 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1740" y="2179506"/>
            <a:ext cx="3976336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" name="Bild 6" descr="MMH3443 ileum-1 1-5 Ki67 x100 scale bar 100um 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2533" y="2160189"/>
            <a:ext cx="3976336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Bild 5" descr="MMH3443 ileum-1 4-1 Ki67 x100 scale bar 100um 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89" y="2157753"/>
            <a:ext cx="3972688" cy="298525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2574336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Proliferating</a:t>
            </a:r>
            <a:r>
              <a:rPr lang="de-DE" sz="4000" b="1" dirty="0" smtClean="0">
                <a:latin typeface="Arial"/>
                <a:cs typeface="Arial"/>
              </a:rPr>
              <a:t> Cells </a:t>
            </a:r>
            <a:r>
              <a:rPr lang="de-DE" sz="4000" b="1" dirty="0">
                <a:latin typeface="Arial"/>
                <a:cs typeface="Arial"/>
              </a:rPr>
              <a:t>(ILEUM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5166111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Bild 5" descr="MMH3443 ileum-1 1-4 CD3 x100 scale bar 100um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3198" y="2131047"/>
            <a:ext cx="3971718" cy="2984527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" name="Bild 6" descr="MMH3438 ileum 2-5 CD3 x100 scale bar 100um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9338" y="2132466"/>
            <a:ext cx="3976335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Bild 4" descr="MMH3443 ileum-1 4-1 CD3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1" y="2132466"/>
            <a:ext cx="3976958" cy="298846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C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903595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smtClean="0">
                <a:latin typeface="Arial"/>
                <a:cs typeface="Arial"/>
              </a:rPr>
              <a:t>T </a:t>
            </a:r>
            <a:r>
              <a:rPr lang="de-DE" sz="4000" b="1" dirty="0" err="1" smtClean="0">
                <a:latin typeface="Arial"/>
                <a:cs typeface="Arial"/>
              </a:rPr>
              <a:t>Lymphocytes</a:t>
            </a:r>
            <a:r>
              <a:rPr lang="de-DE" sz="4000" b="1" dirty="0" smtClean="0">
                <a:latin typeface="Arial"/>
                <a:cs typeface="Arial"/>
              </a:rPr>
              <a:t> </a:t>
            </a:r>
            <a:r>
              <a:rPr lang="de-DE" sz="4000" b="1" dirty="0">
                <a:latin typeface="Arial"/>
                <a:cs typeface="Arial"/>
              </a:rPr>
              <a:t>(ILEUM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089078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 6" descr="MMH3438 ileum 2-6 B220 x100 scale bar 100um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7914" y="2148145"/>
            <a:ext cx="3976340" cy="2988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Bild 5" descr="MMH3443 ileum-1 1-1 B220 x100 scale bar 100um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3877" y="2132467"/>
            <a:ext cx="3979295" cy="2990222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Bild 4" descr="MMH3443 ileum-1 4-1 B220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71" y="2132467"/>
            <a:ext cx="3964605" cy="2979183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D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778163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smtClean="0">
                <a:latin typeface="Arial"/>
                <a:cs typeface="Arial"/>
              </a:rPr>
              <a:t>B </a:t>
            </a:r>
            <a:r>
              <a:rPr lang="de-DE" sz="4000" b="1" dirty="0" err="1" smtClean="0">
                <a:latin typeface="Arial"/>
                <a:cs typeface="Arial"/>
              </a:rPr>
              <a:t>Lymphocytes</a:t>
            </a:r>
            <a:r>
              <a:rPr lang="de-DE" sz="4000" b="1" dirty="0">
                <a:latin typeface="Arial"/>
                <a:cs typeface="Arial"/>
              </a:rPr>
              <a:t> (ILEUM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958695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Benutzerdefiniert</PresentationFormat>
  <Paragraphs>24</Paragraphs>
  <Slides>4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Charite Universitaetsmedizin Berl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ühl, Anja</dc:creator>
  <cp:lastModifiedBy>Markus Heimesaat</cp:lastModifiedBy>
  <cp:revision>45</cp:revision>
  <cp:lastPrinted>2017-08-16T14:08:43Z</cp:lastPrinted>
  <dcterms:created xsi:type="dcterms:W3CDTF">2017-08-15T15:55:34Z</dcterms:created>
  <dcterms:modified xsi:type="dcterms:W3CDTF">2018-11-16T18:02:57Z</dcterms:modified>
</cp:coreProperties>
</file>